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E764D5-0E66-457C-A01D-6BA29751191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CD3D9A-A774-4E11-8CC1-9191E451CF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DAF3BD-9433-4AC8-90D3-1DE517B1784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73257F-7725-44C7-9F80-A92397F614F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33CE84-704B-48F6-8469-3834382A70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1F1FF4-8D67-4269-B123-9008C6DD9E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2AF109-CAA7-409B-B8A7-A640CB0EFC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92BE1A-B845-4830-85B2-B55A98991B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55C370-2BF3-43D6-AF73-CEEA92D7E6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C03304-C2DD-4E6D-B207-8A0858B51C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5CA644-ED43-42C9-83EF-B21A551FB6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8C06C8-37FF-401B-9B1C-00F1393D7B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F17C8A3-F60A-4B44-A0A9-8467048D578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08000" y="333360"/>
            <a:ext cx="8907480" cy="3490920"/>
          </a:xfrm>
          <a:prstGeom prst="rect">
            <a:avLst/>
          </a:prstGeom>
          <a:ln w="0">
            <a:noFill/>
          </a:ln>
        </p:spPr>
      </p:pic>
      <p:sp>
        <p:nvSpPr>
          <p:cNvPr id="42" name="Text Box 61"/>
          <p:cNvSpPr/>
          <p:nvPr/>
        </p:nvSpPr>
        <p:spPr>
          <a:xfrm>
            <a:off x="324000" y="4653000"/>
            <a:ext cx="84960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S2 Fig. Multiple sequence alignment of the four genes encoding for GDH in </a:t>
            </a:r>
            <a:r>
              <a:rPr b="1" i="1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L. japonicus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 The alignment was carried out using ClustalW with the Gonnet protein weight matrix and a gap open penalty of 10. The theoretical molecular weight of the polypeptides are of 44.74, 44.72, 44.66 and 70.74 kDa for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 LjGDH1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LjGDH2,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LjGDH3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and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LjGDH4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respectively. A dehydrogenase dimerization domain (pfam02812) between the amino acids 240 and 360 of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LjGDH4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and the NAD(P)-binding domain of GDH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from the amino acid 379 to the end of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LjGDH4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were detected using the BLASTP program at NCBI (http://blast.ncbi.nlm.nih.gov/Blast.cgi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04T09:11:53Z</dcterms:created>
  <dc:creator>Mao</dc:creator>
  <dc:description/>
  <dc:language>en-US</dc:language>
  <cp:lastModifiedBy>Mao</cp:lastModifiedBy>
  <dcterms:modified xsi:type="dcterms:W3CDTF">2015-01-13T15:41:33Z</dcterms:modified>
  <cp:revision>7</cp:revision>
  <dc:subject/>
  <dc:title>Diapositiva 1</dc:title>
</cp:coreProperties>
</file>